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  <p:sldId id="261" r:id="rId4"/>
    <p:sldId id="262" r:id="rId5"/>
    <p:sldId id="264" r:id="rId6"/>
    <p:sldId id="265" r:id="rId7"/>
    <p:sldId id="267" r:id="rId8"/>
    <p:sldId id="268" r:id="rId9"/>
    <p:sldId id="269" r:id="rId10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7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02" y="72"/>
      </p:cViewPr>
      <p:guideLst>
        <p:guide orient="horz" pos="10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6441-A966-48DB-85C4-BA6BC9D194F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0969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26DC8-E51D-481D-AAD8-A43A9DFD3B2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48115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BD760-98FC-4C08-A0F8-5A963CD3BC8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4027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9005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949C4-1DE5-4F70-8142-6CF1BB24FEA7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72095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8FA0B-0612-4E20-BCBE-87F7BED20B0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95489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D3FC5-249B-4B4C-A869-F27D2287A69E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082196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286D-970A-40DF-86E4-A03FBAF9B186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05276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B30D-BE39-4293-9BDC-450C31B1B31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1334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4F7FA-888C-4CDC-ACC9-A1F66DFE1ECB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8896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14D75-D436-47E2-BF8B-27FD76561BE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58800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56513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140" y="1621450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54135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2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24343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474083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3" name="TextovéPole 22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502349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2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261744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345581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933660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2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322317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4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26944"/>
            <a:ext cx="7584963" cy="3429007"/>
          </a:xfrm>
          <a:prstGeom prst="rect">
            <a:avLst/>
          </a:prstGeom>
        </p:spPr>
      </p:pic>
      <p:sp>
        <p:nvSpPr>
          <p:cNvPr id="21" name="Volný tvar 20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increasing length of the missing wedge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amp 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481070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390</Words>
  <Application>Microsoft Office PowerPoint</Application>
  <PresentationFormat>Předvádění na obrazovce (4:3)</PresentationFormat>
  <Paragraphs>33</Paragraphs>
  <Slides>9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6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DejaVu Sans</vt:lpstr>
      <vt:lpstr>Lohit Hindi</vt:lpstr>
      <vt:lpstr>Tahoma</vt:lpstr>
      <vt:lpstr>Defaul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UBBP 1. LF U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bomir Kovacik</dc:creator>
  <cp:lastModifiedBy>Lubomir Kovacik</cp:lastModifiedBy>
  <cp:revision>23</cp:revision>
  <dcterms:created xsi:type="dcterms:W3CDTF">2014-01-07T09:01:08Z</dcterms:created>
  <dcterms:modified xsi:type="dcterms:W3CDTF">2014-01-07T11:44:20Z</dcterms:modified>
</cp:coreProperties>
</file>